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</p:sldIdLst>
  <p:sldSz cx="6858000" cy="9906000" type="A4"/>
  <p:notesSz cx="6858000" cy="9144000"/>
  <p:defaultTextStyle>
    <a:defPPr>
      <a:defRPr lang="he-I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34536" autoAdjust="0"/>
    <p:restoredTop sz="94660"/>
  </p:normalViewPr>
  <p:slideViewPr>
    <p:cSldViewPr snapToGrid="0" showGuides="1">
      <p:cViewPr>
        <p:scale>
          <a:sx n="80" d="100"/>
          <a:sy n="80" d="100"/>
        </p:scale>
        <p:origin x="1077" y="3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שקופית כותרת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he-IL"/>
              <a:t>לחץ כדי לערוך סגנון כותרת של תבנית בסיס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he-IL"/>
              <a:t>לחץ כדי לערוך סגנון כותרת משנה של תבנית בסיס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C22102-17BF-44BC-8CE9-F5420CDD7C55}" type="datetimeFigureOut">
              <a:rPr lang="he-IL" smtClean="0"/>
              <a:t>ד'/תשרי/תשפ"ג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2E5FBD-CBCF-4FA2-ABDC-E7C61142C385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5423851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כותרת וטקסט אנכ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/>
              <a:t>לחץ כדי לערוך סגנון כותרת של תבנית בסיס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C22102-17BF-44BC-8CE9-F5420CDD7C55}" type="datetimeFigureOut">
              <a:rPr lang="he-IL" smtClean="0"/>
              <a:t>ד'/תשרי/תשפ"ג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2E5FBD-CBCF-4FA2-ABDC-E7C61142C385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7579265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כותרת אנכית וטקס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he-IL"/>
              <a:t>לחץ כדי לערוך סגנון כותרת של תבנית בסיס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C22102-17BF-44BC-8CE9-F5420CDD7C55}" type="datetimeFigureOut">
              <a:rPr lang="he-IL" smtClean="0"/>
              <a:t>ד'/תשרי/תשפ"ג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2E5FBD-CBCF-4FA2-ABDC-E7C61142C385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1807451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כותרת ותוכן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/>
              <a:t>לחץ כדי לערוך סגנון כותרת של תבנית בסיס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C22102-17BF-44BC-8CE9-F5420CDD7C55}" type="datetimeFigureOut">
              <a:rPr lang="he-IL" smtClean="0"/>
              <a:t>ד'/תשרי/תשפ"ג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2E5FBD-CBCF-4FA2-ABDC-E7C61142C385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2649880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כותרת מקטע עליונה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he-IL"/>
              <a:t>לחץ כדי לערוך סגנון כותרת של תבנית בסיס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C22102-17BF-44BC-8CE9-F5420CDD7C55}" type="datetimeFigureOut">
              <a:rPr lang="he-IL" smtClean="0"/>
              <a:t>ד'/תשרי/תשפ"ג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2E5FBD-CBCF-4FA2-ABDC-E7C61142C385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7751375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שני תכנים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/>
              <a:t>לחץ כדי לערוך סגנון כותרת של תבנית בסיס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C22102-17BF-44BC-8CE9-F5420CDD7C55}" type="datetimeFigureOut">
              <a:rPr lang="he-IL" smtClean="0"/>
              <a:t>ד'/תשרי/תשפ"ג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2E5FBD-CBCF-4FA2-ABDC-E7C61142C385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0225879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השוואה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he-IL"/>
              <a:t>לחץ כדי לערוך סגנון כותרת של תבנית בסיס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C22102-17BF-44BC-8CE9-F5420CDD7C55}" type="datetimeFigureOut">
              <a:rPr lang="he-IL" smtClean="0"/>
              <a:t>ד'/תשרי/תשפ"ג</a:t>
            </a:fld>
            <a:endParaRPr lang="he-I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2E5FBD-CBCF-4FA2-ABDC-E7C61142C385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1504450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כותרת בלבד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/>
              <a:t>לחץ כדי לערוך סגנון כותרת של תבנית בסיס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C22102-17BF-44BC-8CE9-F5420CDD7C55}" type="datetimeFigureOut">
              <a:rPr lang="he-IL" smtClean="0"/>
              <a:t>ד'/תשרי/תשפ"ג</a:t>
            </a:fld>
            <a:endParaRPr lang="he-I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2E5FBD-CBCF-4FA2-ABDC-E7C61142C385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2801184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ריק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C22102-17BF-44BC-8CE9-F5420CDD7C55}" type="datetimeFigureOut">
              <a:rPr lang="he-IL" smtClean="0"/>
              <a:t>ד'/תשרי/תשפ"ג</a:t>
            </a:fld>
            <a:endParaRPr lang="he-I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2E5FBD-CBCF-4FA2-ABDC-E7C61142C385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1964224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תוכן עם כיתוב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he-IL"/>
              <a:t>לחץ כדי לערוך סגנון כותרת של תבנית בסיס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C22102-17BF-44BC-8CE9-F5420CDD7C55}" type="datetimeFigureOut">
              <a:rPr lang="he-IL" smtClean="0"/>
              <a:t>ד'/תשרי/תשפ"ג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2E5FBD-CBCF-4FA2-ABDC-E7C61142C385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3271054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תמונה עם כיתוב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he-IL"/>
              <a:t>לחץ כדי לערוך סגנון כותרת של תבנית בסיס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he-IL"/>
              <a:t>לחץ על הסמל כדי להוסיף תמונה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C22102-17BF-44BC-8CE9-F5420CDD7C55}" type="datetimeFigureOut">
              <a:rPr lang="he-IL" smtClean="0"/>
              <a:t>ד'/תשרי/תשפ"ג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2E5FBD-CBCF-4FA2-ABDC-E7C61142C385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1049437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he-IL"/>
              <a:t>לחץ כדי לערוך סגנון כותרת של תבנית בסיס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C22102-17BF-44BC-8CE9-F5420CDD7C55}" type="datetimeFigureOut">
              <a:rPr lang="he-IL" smtClean="0"/>
              <a:t>ד'/תשרי/תשפ"ג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2E5FBD-CBCF-4FA2-ABDC-E7C61142C385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8605333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1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r" defTabSz="685800" rtl="1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מלבן 3"/>
          <p:cNvSpPr/>
          <p:nvPr/>
        </p:nvSpPr>
        <p:spPr>
          <a:xfrm>
            <a:off x="354529" y="540902"/>
            <a:ext cx="6183003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. Figure 1. Comparing cultures that were initiated with </a:t>
            </a:r>
            <a:r>
              <a:rPr lang="en-US" sz="1200" b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resh and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awed PBMCs.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Fold expansion on day 6 and day 10. Fold expansion in comparison to the number of cells taken for transduction on day 2 (n=3).</a:t>
            </a:r>
            <a:endParaRPr lang="en-US" sz="1200" dirty="0"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תמונה 5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82457" y="1546635"/>
            <a:ext cx="3456000" cy="234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042802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ערכת נושא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ערכת נושא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ערכת נושא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1</TotalTime>
  <Words>45</Words>
  <Application>Microsoft Office PowerPoint</Application>
  <PresentationFormat>A4 Paper (210x297 mm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Sheb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יצחקי אורית, דר</dc:creator>
  <cp:lastModifiedBy>michal Besser</cp:lastModifiedBy>
  <cp:revision>11</cp:revision>
  <dcterms:created xsi:type="dcterms:W3CDTF">2022-09-18T07:12:22Z</dcterms:created>
  <dcterms:modified xsi:type="dcterms:W3CDTF">2022-09-29T06:38:58Z</dcterms:modified>
</cp:coreProperties>
</file>